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6" r:id="rId5"/>
    <p:sldId id="262" r:id="rId6"/>
    <p:sldId id="257" r:id="rId7"/>
    <p:sldId id="263" r:id="rId8"/>
    <p:sldId id="264" r:id="rId9"/>
    <p:sldId id="265" r:id="rId10"/>
    <p:sldId id="267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566255-32E8-4BA9-AB52-72EC22FE9B41}" v="17" dt="2024-09-18T18:14:42.07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ess, Julie - REE-ARS" userId="713d60aa-7033-42d4-84fa-f75cf7e12285" providerId="ADAL" clId="{6F566255-32E8-4BA9-AB52-72EC22FE9B41}"/>
    <pc:docChg chg="undo custSel modSld">
      <pc:chgData name="Hess, Julie - REE-ARS" userId="713d60aa-7033-42d4-84fa-f75cf7e12285" providerId="ADAL" clId="{6F566255-32E8-4BA9-AB52-72EC22FE9B41}" dt="2024-09-18T18:15:01.266" v="48" actId="27918"/>
      <pc:docMkLst>
        <pc:docMk/>
      </pc:docMkLst>
      <pc:sldChg chg="addSp delSp modSp mod">
        <pc:chgData name="Hess, Julie - REE-ARS" userId="713d60aa-7033-42d4-84fa-f75cf7e12285" providerId="ADAL" clId="{6F566255-32E8-4BA9-AB52-72EC22FE9B41}" dt="2024-09-18T16:58:06.850" v="6" actId="21"/>
        <pc:sldMkLst>
          <pc:docMk/>
          <pc:sldMk cId="3004740936" sldId="262"/>
        </pc:sldMkLst>
        <pc:spChg chg="add del mod">
          <ac:chgData name="Hess, Julie - REE-ARS" userId="713d60aa-7033-42d4-84fa-f75cf7e12285" providerId="ADAL" clId="{6F566255-32E8-4BA9-AB52-72EC22FE9B41}" dt="2024-09-18T16:58:06.850" v="6" actId="21"/>
          <ac:spMkLst>
            <pc:docMk/>
            <pc:sldMk cId="3004740936" sldId="262"/>
            <ac:spMk id="2" creationId="{FBC90373-C30D-4094-AA64-7F181F0641C8}"/>
          </ac:spMkLst>
        </pc:spChg>
        <pc:spChg chg="add del">
          <ac:chgData name="Hess, Julie - REE-ARS" userId="713d60aa-7033-42d4-84fa-f75cf7e12285" providerId="ADAL" clId="{6F566255-32E8-4BA9-AB52-72EC22FE9B41}" dt="2024-09-18T16:58:05.905" v="4" actId="22"/>
          <ac:spMkLst>
            <pc:docMk/>
            <pc:sldMk cId="3004740936" sldId="262"/>
            <ac:spMk id="4" creationId="{588D911C-A24E-7622-6964-DC33D2E90789}"/>
          </ac:spMkLst>
        </pc:spChg>
      </pc:sldChg>
      <pc:sldChg chg="modSp mod">
        <pc:chgData name="Hess, Julie - REE-ARS" userId="713d60aa-7033-42d4-84fa-f75cf7e12285" providerId="ADAL" clId="{6F566255-32E8-4BA9-AB52-72EC22FE9B41}" dt="2024-09-18T18:15:01.266" v="48" actId="27918"/>
        <pc:sldMkLst>
          <pc:docMk/>
          <pc:sldMk cId="2432572066" sldId="267"/>
        </pc:sldMkLst>
        <pc:graphicFrameChg chg="mod">
          <ac:chgData name="Hess, Julie - REE-ARS" userId="713d60aa-7033-42d4-84fa-f75cf7e12285" providerId="ADAL" clId="{6F566255-32E8-4BA9-AB52-72EC22FE9B41}" dt="2024-09-18T18:14:35.584" v="45"/>
          <ac:graphicFrameMkLst>
            <pc:docMk/>
            <pc:sldMk cId="2432572066" sldId="267"/>
            <ac:graphicFrameMk id="2" creationId="{D67F74B2-4CC9-4977-892F-0D741CE31747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sdagcc.sharepoint.com/sites/REE-ARS-PA-3062-Hess-Lab/Shared%20Documents/General/Food%20Processing%20Levels/Unprocessed%20SAD/Write%20up/Radar%20Plots%20Western%20vs.%20SAD%20HEI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71604102447976"/>
          <c:y val="8.606360588904291E-2"/>
          <c:w val="0.52888766470359283"/>
          <c:h val="0.76479477536618223"/>
        </c:manualLayout>
      </c:layout>
      <c:radarChart>
        <c:radarStyle val="marker"/>
        <c:varyColors val="0"/>
        <c:ser>
          <c:idx val="0"/>
          <c:order val="0"/>
          <c:tx>
            <c:strRef>
              <c:f>'all radar plots'!$E$2</c:f>
              <c:strCache>
                <c:ptCount val="1"/>
                <c:pt idx="0">
                  <c:v>"Perfect" Healthy Eating Index-2015 Scor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extLst>
                <c:ext xmlns:c15="http://schemas.microsoft.com/office/drawing/2012/chart" uri="{02D57815-91ED-43cb-92C2-25804820EDAC}">
                  <c15:fullRef>
                    <c15:sqref>'all radar plots'!$B$3:$B$15</c15:sqref>
                  </c15:fullRef>
                </c:ext>
              </c:extLst>
              <c:f>'all radar plots'!$B$3:$B$15</c:f>
              <c:strCache>
                <c:ptCount val="13"/>
                <c:pt idx="0">
                  <c:v>Total vegetables</c:v>
                </c:pt>
                <c:pt idx="1">
                  <c:v>Greens &amp; beans</c:v>
                </c:pt>
                <c:pt idx="2">
                  <c:v>Total fruits</c:v>
                </c:pt>
                <c:pt idx="3">
                  <c:v>Whole fruits</c:v>
                </c:pt>
                <c:pt idx="4">
                  <c:v>Whole grains</c:v>
                </c:pt>
                <c:pt idx="5">
                  <c:v>Dairy</c:v>
                </c:pt>
                <c:pt idx="6">
                  <c:v>Total protein foods</c:v>
                </c:pt>
                <c:pt idx="7">
                  <c:v>Seafood &amp; plant proteins</c:v>
                </c:pt>
                <c:pt idx="8">
                  <c:v>Fatty Acids</c:v>
                </c:pt>
                <c:pt idx="9">
                  <c:v>Sodium</c:v>
                </c:pt>
                <c:pt idx="10">
                  <c:v>Refined grains</c:v>
                </c:pt>
                <c:pt idx="11">
                  <c:v>Saturated fats</c:v>
                </c:pt>
                <c:pt idx="12">
                  <c:v>Added sugars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'all radar plots'!$E$3:$E$16</c15:sqref>
                  </c15:fullRef>
                </c:ext>
              </c:extLst>
              <c:f>'all radar plots'!$E$3:$E$15</c:f>
              <c:numCache>
                <c:formatCode>General</c:formatCode>
                <c:ptCount val="1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</c:numCache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0-0EB9-4C91-A727-A7C4FF0C3A73}"/>
            </c:ext>
          </c:extLst>
        </c:ser>
        <c:ser>
          <c:idx val="1"/>
          <c:order val="1"/>
          <c:tx>
            <c:strRef>
              <c:f>'all radar plots'!$G$2</c:f>
              <c:strCache>
                <c:ptCount val="1"/>
                <c:pt idx="0">
                  <c:v>Less-Processed Western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extLst>
                <c:ext xmlns:c15="http://schemas.microsoft.com/office/drawing/2012/chart" uri="{02D57815-91ED-43cb-92C2-25804820EDAC}">
                  <c15:fullRef>
                    <c15:sqref>'all radar plots'!$B$3:$B$15</c15:sqref>
                  </c15:fullRef>
                </c:ext>
              </c:extLst>
              <c:f>'all radar plots'!$B$3:$B$15</c:f>
              <c:strCache>
                <c:ptCount val="13"/>
                <c:pt idx="0">
                  <c:v>Total vegetables</c:v>
                </c:pt>
                <c:pt idx="1">
                  <c:v>Greens &amp; beans</c:v>
                </c:pt>
                <c:pt idx="2">
                  <c:v>Total fruits</c:v>
                </c:pt>
                <c:pt idx="3">
                  <c:v>Whole fruits</c:v>
                </c:pt>
                <c:pt idx="4">
                  <c:v>Whole grains</c:v>
                </c:pt>
                <c:pt idx="5">
                  <c:v>Dairy</c:v>
                </c:pt>
                <c:pt idx="6">
                  <c:v>Total protein foods</c:v>
                </c:pt>
                <c:pt idx="7">
                  <c:v>Seafood &amp; plant proteins</c:v>
                </c:pt>
                <c:pt idx="8">
                  <c:v>Fatty Acids</c:v>
                </c:pt>
                <c:pt idx="9">
                  <c:v>Sodium</c:v>
                </c:pt>
                <c:pt idx="10">
                  <c:v>Refined grains</c:v>
                </c:pt>
                <c:pt idx="11">
                  <c:v>Saturated fats</c:v>
                </c:pt>
                <c:pt idx="12">
                  <c:v>Added sugars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'all radar plots'!$G$3:$G$15</c15:sqref>
                  </c15:fullRef>
                </c:ext>
              </c:extLst>
              <c:f>'all radar plots'!$G$3:$G$15</c:f>
              <c:numCache>
                <c:formatCode>General</c:formatCode>
                <c:ptCount val="13"/>
                <c:pt idx="0">
                  <c:v>52.407579999999996</c:v>
                </c:pt>
                <c:pt idx="1">
                  <c:v>38.700511999999996</c:v>
                </c:pt>
                <c:pt idx="2">
                  <c:v>62.567214000000007</c:v>
                </c:pt>
                <c:pt idx="3">
                  <c:v>0</c:v>
                </c:pt>
                <c:pt idx="4">
                  <c:v>5.7736939999999999</c:v>
                </c:pt>
                <c:pt idx="5">
                  <c:v>45.339632999999999</c:v>
                </c:pt>
                <c:pt idx="6">
                  <c:v>100</c:v>
                </c:pt>
                <c:pt idx="7">
                  <c:v>47.093696999999999</c:v>
                </c:pt>
                <c:pt idx="8">
                  <c:v>27.333360000000003</c:v>
                </c:pt>
                <c:pt idx="9">
                  <c:v>78.385553999999999</c:v>
                </c:pt>
                <c:pt idx="10">
                  <c:v>62.764859999999999</c:v>
                </c:pt>
                <c:pt idx="11">
                  <c:v>15.705552000000001</c:v>
                </c:pt>
                <c:pt idx="12">
                  <c:v>32.394266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EB9-4C91-A727-A7C4FF0C3A73}"/>
            </c:ext>
          </c:extLst>
        </c:ser>
        <c:ser>
          <c:idx val="2"/>
          <c:order val="2"/>
          <c:tx>
            <c:strRef>
              <c:f>'all radar plots'!$F$2</c:f>
              <c:strCache>
                <c:ptCount val="1"/>
                <c:pt idx="0">
                  <c:v>Adjusted Less-Processed Western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extLst>
                <c:ext xmlns:c15="http://schemas.microsoft.com/office/drawing/2012/chart" uri="{02D57815-91ED-43cb-92C2-25804820EDAC}">
                  <c15:fullRef>
                    <c15:sqref>'all radar plots'!$B$3:$B$15</c15:sqref>
                  </c15:fullRef>
                </c:ext>
              </c:extLst>
              <c:f>'all radar plots'!$B$3:$B$15</c:f>
              <c:strCache>
                <c:ptCount val="13"/>
                <c:pt idx="0">
                  <c:v>Total vegetables</c:v>
                </c:pt>
                <c:pt idx="1">
                  <c:v>Greens &amp; beans</c:v>
                </c:pt>
                <c:pt idx="2">
                  <c:v>Total fruits</c:v>
                </c:pt>
                <c:pt idx="3">
                  <c:v>Whole fruits</c:v>
                </c:pt>
                <c:pt idx="4">
                  <c:v>Whole grains</c:v>
                </c:pt>
                <c:pt idx="5">
                  <c:v>Dairy</c:v>
                </c:pt>
                <c:pt idx="6">
                  <c:v>Total protein foods</c:v>
                </c:pt>
                <c:pt idx="7">
                  <c:v>Seafood &amp; plant proteins</c:v>
                </c:pt>
                <c:pt idx="8">
                  <c:v>Fatty Acids</c:v>
                </c:pt>
                <c:pt idx="9">
                  <c:v>Sodium</c:v>
                </c:pt>
                <c:pt idx="10">
                  <c:v>Refined grains</c:v>
                </c:pt>
                <c:pt idx="11">
                  <c:v>Saturated fats</c:v>
                </c:pt>
                <c:pt idx="12">
                  <c:v>Added sugars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'all radar plots'!$F$3:$F$15</c15:sqref>
                  </c15:fullRef>
                </c:ext>
              </c:extLst>
              <c:f>'all radar plots'!$F$3:$F$15</c:f>
              <c:numCache>
                <c:formatCode>General</c:formatCode>
                <c:ptCount val="13"/>
                <c:pt idx="0">
                  <c:v>53.438417999999999</c:v>
                </c:pt>
                <c:pt idx="1">
                  <c:v>39.469698000000001</c:v>
                </c:pt>
                <c:pt idx="2">
                  <c:v>62.885723999999996</c:v>
                </c:pt>
                <c:pt idx="3">
                  <c:v>0</c:v>
                </c:pt>
                <c:pt idx="4">
                  <c:v>0.23047600000000004</c:v>
                </c:pt>
                <c:pt idx="5">
                  <c:v>49.224933999999998</c:v>
                </c:pt>
                <c:pt idx="6">
                  <c:v>100</c:v>
                </c:pt>
                <c:pt idx="7">
                  <c:v>42.129516999999993</c:v>
                </c:pt>
                <c:pt idx="8">
                  <c:v>34.955891999999999</c:v>
                </c:pt>
                <c:pt idx="9">
                  <c:v>75.473557999999997</c:v>
                </c:pt>
                <c:pt idx="10">
                  <c:v>50.995248000000004</c:v>
                </c:pt>
                <c:pt idx="11">
                  <c:v>30.125725000000003</c:v>
                </c:pt>
                <c:pt idx="12">
                  <c:v>31.767113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EB9-4C91-A727-A7C4FF0C3A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3655871"/>
        <c:axId val="1544947071"/>
        <c:extLst/>
      </c:radarChart>
      <c:catAx>
        <c:axId val="11036558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4947071"/>
        <c:crosses val="autoZero"/>
        <c:auto val="1"/>
        <c:lblAlgn val="ctr"/>
        <c:lblOffset val="100"/>
        <c:noMultiLvlLbl val="0"/>
      </c:catAx>
      <c:valAx>
        <c:axId val="154494707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0365587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4318079315068327"/>
          <c:y val="0.93661655938662958"/>
          <c:w val="0.65280195888695947"/>
          <c:h val="3.83289319642410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738E6-A285-46EA-BB2A-0559A38641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86D4E5-4C89-467B-8AE9-8A8345A657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9846D0-74C1-4027-ABD2-29EE62719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A691A8-FCE0-4D25-9587-F56767109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00CE4E-1A72-4F26-BCA9-8110D1BD3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953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8A42A8-9573-4655-844D-B00ECDCD41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5CF91D-5E0E-4B37-82D6-6847888393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DBD66C-36BE-4532-8CC0-6725A5093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061F3-3138-4A6D-89A9-815A0B53F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74BBF5-9E72-4CDB-ABE0-43A87B183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484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0564D4-3274-48BA-BE79-A39A843395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245531-5731-452E-ABA6-80FF7B47D6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E68F0F-0C7C-43FD-B2F6-7FC75E00E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A73E03-CF0B-4BA5-9FD7-094E60D75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3CC50A-898D-4D1D-B3C3-58A6EEFB8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902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061A5-F297-494D-B301-BFED44E9AA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DDDBDC-05BA-44B3-810A-074C7CBF00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94E2A2-A01C-4BA0-BBC2-F547F33FE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EEFD12-D48E-4A1D-813A-C41E5621F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FD8BE-CFF6-4383-9D19-9AA19863B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897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5A4812-7ADB-44BB-A835-0781DC85A6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809DC4-8286-4F36-A416-93DD868A92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538630-3C80-458D-A2D9-2AB40976E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CECDD1-CCF4-4BFF-A1B1-38E1944AC1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297743-46EA-4F26-AF2A-DCF435AD8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661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EFECCF-7279-4892-A639-AE8F9E8D6C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2CC1AE-00E0-4654-95B7-066972D12F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379016-2C60-4424-B1CF-4CA254C179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F99AEB-0D19-4602-B64A-6CB21B51D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B7ED86-DC71-409B-90FB-A89C04F23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2B8FCE-95D1-4406-AC0D-1CCB87686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594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559BE-3F99-45CB-907C-907554B4B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850AE5-DF4B-471A-8CD6-8A73138A01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579B8D-2E94-4614-9F16-CF4B70DDC5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1E348AF-0CA4-4EA6-9CC3-293F578C89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478D60-D3FF-47A6-BDC9-005205ECCE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36E49EC-2B47-4C38-AD28-832A7A0FB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4B32981-4888-435C-B5B1-C13857ABC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1E7706-50B9-4BFF-B9F5-7D276BECA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875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3C389-B4DA-4090-8FEC-19FCC9D7EF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06A164-C573-43AB-96B0-EF0DBB751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B21B0D-ED00-4FDC-A13A-43C3EC3D32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243EF0-8FF5-4CFD-87EF-7422CE0D2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363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208571-7E1C-4B16-939F-7767FD174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D72E06A-C3DE-4F29-B482-F79EF8E7B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B5A30F-15AF-489A-9EA1-45BCDBEA4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213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03B03D-1B41-42D2-912C-108804546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985A73-D151-4C32-89D4-72FF02A7C0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998A8E-2A32-4C38-BD40-8B08C4AC61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F7AC21-43B9-433C-B515-748CCF1DCD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985CF4-70D9-42B0-B868-21C34C36C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1C1BE9-6337-4C15-8ECE-287922D10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592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98B64A-3D54-45E1-BB0D-CC05C0978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1D78CE-41DB-41F6-9280-06D9B420AD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E87B43-D36A-461D-832F-4D32FF7D97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D703C6-D3C6-4AD5-ADE4-4657D4D1B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C8707C-D28B-4801-A129-61F1CBF27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BD4DAA-DF17-4A2E-9069-029EF670D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101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8D1586E-B8B0-4B37-8A4D-E58A64851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F07A75-55DC-4830-A9B9-1CDD646CFA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5106D5-A7E7-4A95-B246-BEA7301572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C4B26-A835-4C12-8335-505D437D1F80}" type="datetimeFigureOut">
              <a:rPr lang="en-US" smtClean="0"/>
              <a:t>9/1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AAA36D-B90E-4101-A4E8-A39B5C8FA9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3B4672-439E-418E-82D0-C9E6E95E75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613A7-FFF8-4319-BC5F-6E6633976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886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2882379A-3B31-FDA8-81FE-DACA1CE226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spcBef>
                <a:spcPts val="0"/>
              </a:spcBef>
            </a:pPr>
            <a:r>
              <a:rPr lang="en-US" sz="2500" b="1" i="1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itle: </a:t>
            </a:r>
            <a:r>
              <a:rPr lang="en-US" sz="2500" i="1" kern="0" dirty="0">
                <a:latin typeface="Calibri" panose="020F0502020204030204" pitchFamily="34" charset="0"/>
                <a:cs typeface="Calibri" panose="020F0502020204030204" pitchFamily="34" charset="0"/>
              </a:rPr>
              <a:t>Unprocessed, but SAD: A Standard American Diet Made with Less-Processed Foods is still a Standard American Diet </a:t>
            </a:r>
            <a:b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2500" b="1" i="1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rst Author: </a:t>
            </a:r>
            <a:r>
              <a:rPr lang="en-US" sz="2500" b="0" i="1" kern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ss, Julie M</a:t>
            </a:r>
            <a:endParaRPr lang="en-US" sz="2500" b="1" dirty="0"/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5D200A47-D2BE-B71E-A548-48FFE73FFA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sz="2800" dirty="0"/>
              <a:t>Online Supplementary Material– Supplemental Fig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95973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55">
            <a:extLst>
              <a:ext uri="{FF2B5EF4-FFF2-40B4-BE49-F238E27FC236}">
                <a16:creationId xmlns:a16="http://schemas.microsoft.com/office/drawing/2014/main" id="{D48867F2-4267-49A4-A2DF-1BB03154DA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7871" y="0"/>
            <a:ext cx="5976257" cy="6858000"/>
          </a:xfrm>
          <a:prstGeom prst="rect">
            <a:avLst/>
          </a:prstGeom>
        </p:spPr>
      </p:pic>
      <p:sp>
        <p:nvSpPr>
          <p:cNvPr id="2" name="Rectangle 2">
            <a:extLst>
              <a:ext uri="{FF2B5EF4-FFF2-40B4-BE49-F238E27FC236}">
                <a16:creationId xmlns:a16="http://schemas.microsoft.com/office/drawing/2014/main" id="{FBC90373-C30D-4094-AA64-7F181F0641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695" y="220576"/>
            <a:ext cx="1127094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8872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ure 1.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47409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1CF9B91A-0A41-4A53-909F-2CE949DE6B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5127" y="636617"/>
            <a:ext cx="9277342" cy="37968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68224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3F5D35DA-777B-4926-8567-A941156306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4764" y="478536"/>
            <a:ext cx="10142472" cy="3636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0129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EDB7B01-A72B-4C0E-85CA-354CF37971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7588" y="500125"/>
            <a:ext cx="7220712" cy="52496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26730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17E687AD-48F0-47FB-A566-785840C41158}"/>
              </a:ext>
            </a:extLst>
          </p:cNvPr>
          <p:cNvGrpSpPr/>
          <p:nvPr/>
        </p:nvGrpSpPr>
        <p:grpSpPr>
          <a:xfrm>
            <a:off x="393699" y="381000"/>
            <a:ext cx="8534401" cy="6985000"/>
            <a:chOff x="2590799" y="0"/>
            <a:chExt cx="8284575" cy="68580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6D7EF84-60D6-406F-8F61-8A747381E2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252"/>
            <a:stretch/>
          </p:blipFill>
          <p:spPr>
            <a:xfrm>
              <a:off x="2590799" y="0"/>
              <a:ext cx="7175679" cy="68580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1A52E36-E2B4-4BBB-9EF4-2F696F80394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55900" y="4883913"/>
              <a:ext cx="8119474" cy="41198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157696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3">
            <a:extLst>
              <a:ext uri="{FF2B5EF4-FFF2-40B4-BE49-F238E27FC236}">
                <a16:creationId xmlns:a16="http://schemas.microsoft.com/office/drawing/2014/main" id="{B50B9AE3-2DA5-434E-B448-8D0410B04B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108" y="4025348"/>
            <a:ext cx="20143304" cy="6471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D67F74B2-4CC9-4977-892F-0D741CE317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1753652"/>
              </p:ext>
            </p:extLst>
          </p:nvPr>
        </p:nvGraphicFramePr>
        <p:xfrm>
          <a:off x="1822214" y="436020"/>
          <a:ext cx="9061809" cy="62666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813C8BC4-BE5E-F861-97C3-DC2DD3F02D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695" y="220576"/>
            <a:ext cx="11270941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8872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ure 2.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2572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2">
      <a:dk1>
        <a:sysClr val="windowText" lastClr="000000"/>
      </a:dk1>
      <a:lt1>
        <a:sysClr val="window" lastClr="FFFFFF"/>
      </a:lt1>
      <a:dk2>
        <a:srgbClr val="454551"/>
      </a:dk2>
      <a:lt2>
        <a:srgbClr val="D8D9DC"/>
      </a:lt2>
      <a:accent1>
        <a:srgbClr val="FF0000"/>
      </a:accent1>
      <a:accent2>
        <a:srgbClr val="00B050"/>
      </a:accent2>
      <a:accent3>
        <a:srgbClr val="0070C0"/>
      </a:accent3>
      <a:accent4>
        <a:srgbClr val="EF8011"/>
      </a:accent4>
      <a:accent5>
        <a:srgbClr val="7030A0"/>
      </a:accent5>
      <a:accent6>
        <a:srgbClr val="D54773"/>
      </a:accent6>
      <a:hlink>
        <a:srgbClr val="6B9F25"/>
      </a:hlink>
      <a:folHlink>
        <a:srgbClr val="8C8C8C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d6e34af-da42-4fb4-9de5-937852e315b5">
      <Terms xmlns="http://schemas.microsoft.com/office/infopath/2007/PartnerControls"/>
    </lcf76f155ced4ddcb4097134ff3c332f>
    <TaxCatchAll xmlns="73fb875a-8af9-4255-b008-0995492d31cd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5A33615CD7A59409B453317EF3A2270" ma:contentTypeVersion="16" ma:contentTypeDescription="Create a new document." ma:contentTypeScope="" ma:versionID="8a27be8b05bdd3810222886fdf679838">
  <xsd:schema xmlns:xsd="http://www.w3.org/2001/XMLSchema" xmlns:xs="http://www.w3.org/2001/XMLSchema" xmlns:p="http://schemas.microsoft.com/office/2006/metadata/properties" xmlns:ns2="bd6e34af-da42-4fb4-9de5-937852e315b5" xmlns:ns3="73fb875a-8af9-4255-b008-0995492d31cd" xmlns:ns4="84e34b61-acb3-4f16-b0c0-8e3072f0f4f8" targetNamespace="http://schemas.microsoft.com/office/2006/metadata/properties" ma:root="true" ma:fieldsID="70434b387789d77da39f31481b5e9be0" ns2:_="" ns3:_="" ns4:_="">
    <xsd:import namespace="bd6e34af-da42-4fb4-9de5-937852e315b5"/>
    <xsd:import namespace="73fb875a-8af9-4255-b008-0995492d31cd"/>
    <xsd:import namespace="84e34b61-acb3-4f16-b0c0-8e3072f0f4f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AutoTags" minOccurs="0"/>
                <xsd:element ref="ns2:MediaServiceLocatio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4:SharedWithUsers" minOccurs="0"/>
                <xsd:element ref="ns4:SharedWithDetails" minOccurs="0"/>
                <xsd:element ref="ns2:MediaServiceObjectDetectorVersions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d6e34af-da42-4fb4-9de5-937852e315b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Location" ma:index="12" nillable="true" ma:displayName="Location" ma:internalName="MediaServiceLocation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8ff62593-b918-4deb-ac08-0d74ac0cc7e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3fb875a-8af9-4255-b008-0995492d31cd" elementFormDefault="qualified">
    <xsd:import namespace="http://schemas.microsoft.com/office/2006/documentManagement/types"/>
    <xsd:import namespace="http://schemas.microsoft.com/office/infopath/2007/PartnerControls"/>
    <xsd:element name="TaxCatchAll" ma:index="18" nillable="true" ma:displayName="Taxonomy Catch All Column" ma:hidden="true" ma:list="{8f1ba205-e190-4b93-9314-603a50c6d7bf}" ma:internalName="TaxCatchAll" ma:showField="CatchAllData" ma:web="84e34b61-acb3-4f16-b0c0-8e3072f0f4f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4e34b61-acb3-4f16-b0c0-8e3072f0f4f8" elementFormDefault="qualified">
    <xsd:import namespace="http://schemas.microsoft.com/office/2006/documentManagement/types"/>
    <xsd:import namespace="http://schemas.microsoft.com/office/infopath/2007/PartnerControls"/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0D930BA-0A06-424C-8191-FE3550DDED8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6170C4E-1C4D-4043-BB17-643E4739B4F0}">
  <ds:schemaRefs>
    <ds:schemaRef ds:uri="http://schemas.microsoft.com/office/2006/documentManagement/types"/>
    <ds:schemaRef ds:uri="http://purl.org/dc/terms/"/>
    <ds:schemaRef ds:uri="http://schemas.microsoft.com/office/2006/metadata/properties"/>
    <ds:schemaRef ds:uri="ab9709a2-40a6-4104-a124-1523261163f4"/>
    <ds:schemaRef ds:uri="http://schemas.microsoft.com/office/infopath/2007/PartnerControls"/>
    <ds:schemaRef ds:uri="http://www.w3.org/XML/1998/namespace"/>
    <ds:schemaRef ds:uri="http://purl.org/dc/dcmitype/"/>
    <ds:schemaRef ds:uri="http://schemas.openxmlformats.org/package/2006/metadata/core-properties"/>
    <ds:schemaRef ds:uri="80fcec7b-bc8b-45c9-b71f-eacef9b056e5"/>
    <ds:schemaRef ds:uri="http://purl.org/dc/elements/1.1/"/>
    <ds:schemaRef ds:uri="bd6e34af-da42-4fb4-9de5-937852e315b5"/>
    <ds:schemaRef ds:uri="73fb875a-8af9-4255-b008-0995492d31cd"/>
  </ds:schemaRefs>
</ds:datastoreItem>
</file>

<file path=customXml/itemProps3.xml><?xml version="1.0" encoding="utf-8"?>
<ds:datastoreItem xmlns:ds="http://schemas.openxmlformats.org/officeDocument/2006/customXml" ds:itemID="{1B4C0CE0-6933-4CD6-B83C-A0528A41EE1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d6e34af-da42-4fb4-9de5-937852e315b5"/>
    <ds:schemaRef ds:uri="73fb875a-8af9-4255-b008-0995492d31cd"/>
    <ds:schemaRef ds:uri="84e34b61-acb3-4f16-b0c0-8e3072f0f4f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43</Words>
  <Application>Microsoft Office PowerPoint</Application>
  <PresentationFormat>Widescreen</PresentationFormat>
  <Paragraphs>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Title: Unprocessed, but SAD: A Standard American Diet Made with Less-Processed Foods is still a Standard American Diet  First Author: Hess, Julie M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ss, Julie - ARS</dc:creator>
  <cp:lastModifiedBy>Hess, Julie - REE-ARS</cp:lastModifiedBy>
  <cp:revision>5</cp:revision>
  <dcterms:created xsi:type="dcterms:W3CDTF">2022-10-19T16:38:37Z</dcterms:created>
  <dcterms:modified xsi:type="dcterms:W3CDTF">2024-09-18T18:15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5A33615CD7A59409B453317EF3A2270</vt:lpwstr>
  </property>
  <property fmtid="{D5CDD505-2E9C-101B-9397-08002B2CF9AE}" pid="3" name="MediaServiceImageTags">
    <vt:lpwstr/>
  </property>
</Properties>
</file>